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9" r:id="rId3"/>
    <p:sldId id="261" r:id="rId4"/>
    <p:sldId id="260" r:id="rId5"/>
    <p:sldId id="264" r:id="rId6"/>
    <p:sldId id="263" r:id="rId7"/>
    <p:sldId id="265" r:id="rId8"/>
    <p:sldId id="282" r:id="rId9"/>
    <p:sldId id="283" r:id="rId10"/>
    <p:sldId id="284" r:id="rId1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7D15C021-44D4-C8A7-EA21-CEB8FAA84AD6}" name="Peregrine Green" initials="PG" userId="S::kebl5573@ox.ac.uk::ab7311e8-0249-4a51-9924-58eba7b140b1" providerId="AD"/>
  <p188:author id="{7B8E5CFF-D645-F96A-99B9-F11D7F387B5F}" name="Benjamin Bussmann" initials="" userId="S::newc3833@ox.ac.uk::3dd3379e-0196-4af0-bf6d-f2f8ae7d7e55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429"/>
    <p:restoredTop sz="94610"/>
  </p:normalViewPr>
  <p:slideViewPr>
    <p:cSldViewPr snapToGrid="0">
      <p:cViewPr varScale="1">
        <p:scale>
          <a:sx n="111" d="100"/>
          <a:sy n="111" d="100"/>
        </p:scale>
        <p:origin x="320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microsoft.com/office/2018/10/relationships/authors" Target="author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C605F0-2546-A28E-EDC3-11417DD3459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5FB620D-1DCC-8DFA-23BD-4D83EC88715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0D9200-5B11-77D9-A68B-7250184791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7FF0DC-3208-AA44-9C73-ECD29E109270}" type="datetimeFigureOut">
              <a:rPr lang="en-US" smtClean="0"/>
              <a:t>2/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E3D21B-22E0-0DE2-3E5D-85241080B4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E2796E-24BF-D3B8-0F85-D53CB4440C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DDEE4-18E8-B043-B44A-A2FDAB7C79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48863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FA212D-148D-A89B-FA7C-1332F43864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CDB446C-4120-0BF6-95A3-EA5217554A0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866214-93DC-0D32-3A89-B3368E2B77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7FF0DC-3208-AA44-9C73-ECD29E109270}" type="datetimeFigureOut">
              <a:rPr lang="en-US" smtClean="0"/>
              <a:t>2/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922E2E-5909-748C-AD0E-D2E58F2661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06DCF2-1A55-36A0-FCC0-D287B1CD31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DDEE4-18E8-B043-B44A-A2FDAB7C79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42137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D26D135-B896-248B-465E-D13D2569AC1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902D8D6-846E-2DEB-395B-06EFA678BC6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1862FA-166B-A653-AA32-91753B7BB1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7FF0DC-3208-AA44-9C73-ECD29E109270}" type="datetimeFigureOut">
              <a:rPr lang="en-US" smtClean="0"/>
              <a:t>2/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AD65B7-0ACC-99D2-27B6-1F12B26231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5C290D-A2EC-2D19-D32A-4A7446C77B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DDEE4-18E8-B043-B44A-A2FDAB7C79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46680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4D73A4-2A67-6159-EF0F-A960A341D5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869478A-4D83-385E-F1BE-841841643AD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E12420-3C61-73C3-1FC0-0DAA98855B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7FF0DC-3208-AA44-9C73-ECD29E109270}" type="datetimeFigureOut">
              <a:rPr lang="en-US" smtClean="0"/>
              <a:t>2/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BF01D9-E64C-C3E2-6851-04372CF3DB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28F181-61B8-BD90-3AE0-5678A25B36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DDEE4-18E8-B043-B44A-A2FDAB7C79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24696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3A054E-82ED-05AE-7BB3-D15A48D17E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4BC72E0-1D67-CF5B-B589-EBF6008F79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9E75B9-DB49-B6A8-6C0F-1459769C48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7FF0DC-3208-AA44-9C73-ECD29E109270}" type="datetimeFigureOut">
              <a:rPr lang="en-US" smtClean="0"/>
              <a:t>2/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38F3E3-972F-93FC-FC17-0E6D272CDF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E2B146-17A1-5E8C-050C-5EF1EA1E8F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DDEE4-18E8-B043-B44A-A2FDAB7C79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98343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46984B-4701-51E9-3AF9-CA94A4407D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890CEBE-FCC5-8D63-6376-C829AEF9913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CBCA1A6-7F68-8748-1CEC-69C5D8C9322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192261F-EC33-43DD-2274-AAE09FADBD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7FF0DC-3208-AA44-9C73-ECD29E109270}" type="datetimeFigureOut">
              <a:rPr lang="en-US" smtClean="0"/>
              <a:t>2/3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4A2E99-2D19-EA10-73AF-D2DEB59E42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31EC0F7-C8D5-8076-30F1-C9AD830A0B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DDEE4-18E8-B043-B44A-A2FDAB7C79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873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1DC21B-3A8B-F70A-D10D-746F111AF5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AE61A5A-562E-9486-3B9A-1E55CA9D7E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347402C-A5B5-64A9-AE71-3AFA151D48F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D32232D-552F-C1E4-B479-CFAE0375C15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3B3B1D8-6BF7-48F8-EDC4-2938A90525E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06CC04E-1B46-ED02-E230-3107114899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7FF0DC-3208-AA44-9C73-ECD29E109270}" type="datetimeFigureOut">
              <a:rPr lang="en-US" smtClean="0"/>
              <a:t>2/3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4EE1166-7A02-1596-99E2-3483E9B3AF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02D1331-8E7A-5A5A-FF05-C44A2AF2D3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DDEE4-18E8-B043-B44A-A2FDAB7C79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3710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99B397-C681-D054-F686-01D16EFE25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67A1003-E86D-15CD-4618-B217634C32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7FF0DC-3208-AA44-9C73-ECD29E109270}" type="datetimeFigureOut">
              <a:rPr lang="en-US" smtClean="0"/>
              <a:t>2/3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ED36728-40D0-BA3A-4FBA-28BB9A6D70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A8267BC-331A-24C8-677D-6524DC20B3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DDEE4-18E8-B043-B44A-A2FDAB7C79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1643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DF95847-AD68-B130-2D28-3C5D6888B9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7FF0DC-3208-AA44-9C73-ECD29E109270}" type="datetimeFigureOut">
              <a:rPr lang="en-US" smtClean="0"/>
              <a:t>2/3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B476E02-9A12-AC6D-D497-713ACA37A4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D45E13A-4C2F-7162-78DA-9E7DB4297B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DDEE4-18E8-B043-B44A-A2FDAB7C79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07625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A67FDB-E7A2-D509-6398-6DACB090D4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4047817-BDD8-3BFE-5285-913695784D6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1ED5A44-324E-6C59-1C84-09BBA9DDE35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FF0C4D0-6F22-4349-45CB-E7236239FE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7FF0DC-3208-AA44-9C73-ECD29E109270}" type="datetimeFigureOut">
              <a:rPr lang="en-US" smtClean="0"/>
              <a:t>2/3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132750E-4BAF-12C3-06E1-2E51A27F72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85204DB-2054-BA8B-5019-269BEB4EC3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DDEE4-18E8-B043-B44A-A2FDAB7C79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06988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AA21E6-29A6-3734-8515-C364EF060D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F7F9C77-A668-1525-2CBF-3C20B607E13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878B4CD-8FA4-7534-C448-BC1BFD7716F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18DC1C2-6DBD-A35D-7AD2-59B8695D1B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7FF0DC-3208-AA44-9C73-ECD29E109270}" type="datetimeFigureOut">
              <a:rPr lang="en-US" smtClean="0"/>
              <a:t>2/3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9BB6199-2148-047B-6F71-C40A88A9A7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B444A02-3F97-86A4-BB9A-8989BD1009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DDEE4-18E8-B043-B44A-A2FDAB7C79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62242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3C83815-561C-CEB8-23A9-B83B6E317C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1C72C74-4ED4-4E01-39C1-61A13D3DAD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232867-A3B6-EAD6-43F4-F0BB11F4ED9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C7FF0DC-3208-AA44-9C73-ECD29E109270}" type="datetimeFigureOut">
              <a:rPr lang="en-US" smtClean="0"/>
              <a:t>2/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CFDE01-FC92-0CF9-A83A-FA707ABE4F4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D6F176-7218-FEBC-A014-DF6A3A6B9F7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DADDEE4-18E8-B043-B44A-A2FDAB7C79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646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jpe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eg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3.jpeg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diagram of different substances&#10;&#10;Description automatically generated with medium confidence">
            <a:extLst>
              <a:ext uri="{FF2B5EF4-FFF2-40B4-BE49-F238E27FC236}">
                <a16:creationId xmlns:a16="http://schemas.microsoft.com/office/drawing/2014/main" id="{3B5AC685-8104-9D12-A263-F18FC71BE1E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98636" y="640470"/>
            <a:ext cx="6370321" cy="4246880"/>
          </a:xfrm>
          <a:prstGeom prst="rect">
            <a:avLst/>
          </a:prstGeom>
        </p:spPr>
      </p:pic>
      <p:pic>
        <p:nvPicPr>
          <p:cNvPr id="8" name="Content Placeholder 7" descr="A graph of different colored squares&#10;&#10;Description automatically generated">
            <a:extLst>
              <a:ext uri="{FF2B5EF4-FFF2-40B4-BE49-F238E27FC236}">
                <a16:creationId xmlns:a16="http://schemas.microsoft.com/office/drawing/2014/main" id="{13596E7E-384D-018C-E51B-472B0D456FA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203723" y="674514"/>
            <a:ext cx="5194913" cy="4155931"/>
          </a:xfr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321EC393-6062-8B4A-F2EE-D7065EE691CB}"/>
              </a:ext>
            </a:extLst>
          </p:cNvPr>
          <p:cNvSpPr txBox="1"/>
          <p:nvPr/>
        </p:nvSpPr>
        <p:spPr>
          <a:xfrm>
            <a:off x="388179" y="489848"/>
            <a:ext cx="33534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3290092-99F4-383F-91C7-A1F30F33ED17}"/>
              </a:ext>
            </a:extLst>
          </p:cNvPr>
          <p:cNvSpPr txBox="1"/>
          <p:nvPr/>
        </p:nvSpPr>
        <p:spPr>
          <a:xfrm>
            <a:off x="5105365" y="489848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B</a:t>
            </a:r>
          </a:p>
        </p:txBody>
      </p:sp>
      <p:sp>
        <p:nvSpPr>
          <p:cNvPr id="9" name="Content Placeholder 2">
            <a:extLst>
              <a:ext uri="{FF2B5EF4-FFF2-40B4-BE49-F238E27FC236}">
                <a16:creationId xmlns:a16="http://schemas.microsoft.com/office/drawing/2014/main" id="{310A8E35-43C4-33F7-D3D2-8A4AA16F139A}"/>
              </a:ext>
            </a:extLst>
          </p:cNvPr>
          <p:cNvSpPr txBox="1">
            <a:spLocks/>
          </p:cNvSpPr>
          <p:nvPr/>
        </p:nvSpPr>
        <p:spPr>
          <a:xfrm>
            <a:off x="285750" y="4944254"/>
            <a:ext cx="11357609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buFont typeface="Arial" panose="020B0604020202020204" pitchFamily="34" charset="0"/>
              <a:buNone/>
            </a:pP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: Left main stem substrate concentrations</a:t>
            </a:r>
          </a:p>
          <a:p>
            <a:pPr marL="0" indent="0" algn="just">
              <a:buFont typeface="Arial" panose="020B0604020202020204" pitchFamily="34" charset="0"/>
              <a:buNone/>
            </a:pP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, Cumulative total left main stem (LMS) concentrations of cardiac substrates while on insulin/glucose and intralipid infusions, during intrinsic conduction and optimized cardiac resynchronization therapy (CRT).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, differences in LMS substrate concentrations during insulin/glucose and intralipid infusions. Data from 11 patients with </a:t>
            </a:r>
            <a:r>
              <a:rPr lang="en-GB" sz="16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 values obtained from paired Wilcoxon signed rank tests.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BOHB,</a:t>
            </a:r>
            <a:r>
              <a:rPr lang="el-GR" sz="1600" dirty="0">
                <a:latin typeface="Arial" panose="020B0604020202020204" pitchFamily="34" charset="0"/>
                <a:cs typeface="Arial" panose="020B0604020202020204" pitchFamily="34" charset="0"/>
              </a:rPr>
              <a:t> β-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hydroxybutyrate;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NEFA, non-esterified free fatty acids.</a:t>
            </a:r>
          </a:p>
          <a:p>
            <a:pPr marL="0" indent="0" algn="just">
              <a:buFont typeface="Arial" panose="020B0604020202020204" pitchFamily="34" charset="0"/>
              <a:buNone/>
            </a:pP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153067200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C381C1F-8145-9A70-2D8B-0998E5F1736A}"/>
              </a:ext>
            </a:extLst>
          </p:cNvPr>
          <p:cNvSpPr txBox="1"/>
          <p:nvPr/>
        </p:nvSpPr>
        <p:spPr>
          <a:xfrm>
            <a:off x="409576" y="4812030"/>
            <a:ext cx="11372849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t</a:t>
            </a: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ble 3: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</a:t>
            </a:r>
          </a:p>
          <a:p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ipidomic analysis illustrating correlations between the increase in NEFA uptake by chain length in response to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ardiac resynchronization therapy on insulin/glucose infusion, and subsequent chronic remodeling of left ventricular end diastolic volume. Data from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8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atients with P values obtained from Spearman correlation </a:t>
            </a:r>
            <a:r>
              <a:rPr lang="en-US" dirty="0">
                <a:latin typeface="Calibri" panose="020F0502020204030204" pitchFamily="34" charset="0"/>
                <a:cs typeface="Times New Roman" panose="02020603050405020304" pitchFamily="18" charset="0"/>
              </a:rPr>
              <a:t>and </a:t>
            </a:r>
            <a:r>
              <a:rPr lang="en-GB" dirty="0">
                <a:latin typeface="Calibri" panose="020F0502020204030204" pitchFamily="34" charset="0"/>
                <a:cs typeface="Times New Roman" panose="02020603050405020304" pitchFamily="18" charset="0"/>
              </a:rPr>
              <a:t>adjusted for false discovery rate with </a:t>
            </a:r>
            <a:r>
              <a:rPr lang="en-GB" dirty="0" err="1">
                <a:latin typeface="Calibri" panose="020F0502020204030204" pitchFamily="34" charset="0"/>
                <a:cs typeface="Times New Roman" panose="02020603050405020304" pitchFamily="18" charset="0"/>
              </a:rPr>
              <a:t>Benjamini</a:t>
            </a:r>
            <a:r>
              <a:rPr lang="en-GB" dirty="0">
                <a:latin typeface="Calibri" panose="020F0502020204030204" pitchFamily="34" charset="0"/>
                <a:cs typeface="Times New Roman" panose="02020603050405020304" pitchFamily="18" charset="0"/>
              </a:rPr>
              <a:t>-Hochberg correction </a:t>
            </a:r>
            <a:r>
              <a:rPr lang="en-US" dirty="0">
                <a:latin typeface="Calibri" panose="020F0502020204030204" pitchFamily="34" charset="0"/>
                <a:cs typeface="Times New Roman" panose="02020603050405020304" pitchFamily="18" charset="0"/>
              </a:rPr>
              <a:t>. </a:t>
            </a:r>
            <a:endParaRPr lang="en-GB" dirty="0">
              <a:latin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A8163B8-001D-005B-D604-35A4B6F5B6AD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1387" t="53671" r="37978" b="28607"/>
          <a:stretch/>
        </p:blipFill>
        <p:spPr>
          <a:xfrm>
            <a:off x="3437681" y="1377386"/>
            <a:ext cx="4942390" cy="24478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874660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 descr="A diagram of insulin resistance&#10;&#10;Description automatically generated with medium confidence">
            <a:extLst>
              <a:ext uri="{FF2B5EF4-FFF2-40B4-BE49-F238E27FC236}">
                <a16:creationId xmlns:a16="http://schemas.microsoft.com/office/drawing/2014/main" id="{B2B0E999-F861-83D5-9221-C8C44F511CC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17247" y="290779"/>
            <a:ext cx="6527007" cy="4351338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3424D7FC-A516-BB65-3020-9E64A6D60B68}"/>
              </a:ext>
            </a:extLst>
          </p:cNvPr>
          <p:cNvSpPr txBox="1"/>
          <p:nvPr/>
        </p:nvSpPr>
        <p:spPr>
          <a:xfrm>
            <a:off x="178184" y="290779"/>
            <a:ext cx="33534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3F15075-326F-41EE-C12D-7A41FF79F426}"/>
              </a:ext>
            </a:extLst>
          </p:cNvPr>
          <p:cNvSpPr txBox="1"/>
          <p:nvPr/>
        </p:nvSpPr>
        <p:spPr>
          <a:xfrm>
            <a:off x="5217247" y="267623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B</a:t>
            </a:r>
          </a:p>
        </p:txBody>
      </p:sp>
      <p:sp>
        <p:nvSpPr>
          <p:cNvPr id="8" name="Content Placeholder 2">
            <a:extLst>
              <a:ext uri="{FF2B5EF4-FFF2-40B4-BE49-F238E27FC236}">
                <a16:creationId xmlns:a16="http://schemas.microsoft.com/office/drawing/2014/main" id="{1C56A25C-1729-B174-8C98-060593732B2B}"/>
              </a:ext>
            </a:extLst>
          </p:cNvPr>
          <p:cNvSpPr txBox="1">
            <a:spLocks/>
          </p:cNvSpPr>
          <p:nvPr/>
        </p:nvSpPr>
        <p:spPr>
          <a:xfrm>
            <a:off x="345858" y="4911725"/>
            <a:ext cx="11398396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buFont typeface="Arial" panose="020B0604020202020204" pitchFamily="34" charset="0"/>
              <a:buNone/>
            </a:pP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: Baseline substrate uptake during intrinsic conduction</a:t>
            </a:r>
          </a:p>
          <a:p>
            <a:pPr marL="0" indent="0" algn="just">
              <a:buFont typeface="Arial" panose="020B0604020202020204" pitchFamily="34" charset="0"/>
              <a:buNone/>
            </a:pP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, Cumulative proportion of cardiac substrate uptake (defined as arterio-venous concentration difference multiplied by left main coronary artery flow) 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during intrinsic conduction while on intralipid and insulin/glucose infusions. </a:t>
            </a:r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, difference in baseline cardiac substrate uptake during insulin/glucose and intralipid infusions during intrinsic conduction. Data from 11  patients with </a:t>
            </a:r>
            <a:r>
              <a:rPr lang="en-GB" sz="16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 values obtained from paired Wilcoxon signed rank tests.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BOHB,</a:t>
            </a:r>
            <a:r>
              <a:rPr lang="el-GR" sz="1600" dirty="0">
                <a:latin typeface="Arial" panose="020B0604020202020204" pitchFamily="34" charset="0"/>
                <a:cs typeface="Arial" panose="020B0604020202020204" pitchFamily="34" charset="0"/>
              </a:rPr>
              <a:t> β-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hydroxybutyrate;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NEFA, non-esterified free fatty acids.</a:t>
            </a:r>
          </a:p>
          <a:p>
            <a:pPr marL="0" indent="0" algn="just">
              <a:buFont typeface="Arial" panose="020B0604020202020204" pitchFamily="34" charset="0"/>
              <a:buNone/>
            </a:pP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Content Placeholder 8" descr="A graph of uptakes during intrinsic conduction&#10;&#10;Description automatically generated">
            <a:extLst>
              <a:ext uri="{FF2B5EF4-FFF2-40B4-BE49-F238E27FC236}">
                <a16:creationId xmlns:a16="http://schemas.microsoft.com/office/drawing/2014/main" id="{DA46C02E-3787-D6B4-7563-B141BFB2D695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513532" y="267623"/>
            <a:ext cx="4351338" cy="4351338"/>
          </a:xfrm>
        </p:spPr>
      </p:pic>
    </p:spTree>
    <p:extLst>
      <p:ext uri="{BB962C8B-B14F-4D97-AF65-F5344CB8AC3E}">
        <p14:creationId xmlns:p14="http://schemas.microsoft.com/office/powerpoint/2010/main" val="28627725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E9A3821A-4B2D-9C57-BE6A-1CA75A414815}"/>
              </a:ext>
            </a:extLst>
          </p:cNvPr>
          <p:cNvSpPr txBox="1"/>
          <p:nvPr/>
        </p:nvSpPr>
        <p:spPr>
          <a:xfrm>
            <a:off x="380186" y="194780"/>
            <a:ext cx="33534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C7FBED9-CEA0-9ECC-6D94-485F1632D461}"/>
              </a:ext>
            </a:extLst>
          </p:cNvPr>
          <p:cNvSpPr txBox="1"/>
          <p:nvPr/>
        </p:nvSpPr>
        <p:spPr>
          <a:xfrm>
            <a:off x="3955870" y="156796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B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DA63971-8445-ABEB-CD4E-7FB117579801}"/>
              </a:ext>
            </a:extLst>
          </p:cNvPr>
          <p:cNvSpPr txBox="1"/>
          <p:nvPr/>
        </p:nvSpPr>
        <p:spPr>
          <a:xfrm>
            <a:off x="7528371" y="198413"/>
            <a:ext cx="3626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C</a:t>
            </a:r>
          </a:p>
        </p:txBody>
      </p:sp>
      <p:sp>
        <p:nvSpPr>
          <p:cNvPr id="8" name="Content Placeholder 2">
            <a:extLst>
              <a:ext uri="{FF2B5EF4-FFF2-40B4-BE49-F238E27FC236}">
                <a16:creationId xmlns:a16="http://schemas.microsoft.com/office/drawing/2014/main" id="{932321DD-EDA3-6F02-1282-EAA4F03E901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07822" y="4628405"/>
            <a:ext cx="11587937" cy="4351338"/>
          </a:xfrm>
        </p:spPr>
        <p:txBody>
          <a:bodyPr>
            <a:normAutofit/>
          </a:bodyPr>
          <a:lstStyle/>
          <a:p>
            <a:pPr marL="0" indent="0" algn="just">
              <a:buNone/>
            </a:pP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3: Cardiac gas exchange and efficiency</a:t>
            </a:r>
          </a:p>
          <a:p>
            <a:pPr marL="0" indent="0" algn="just">
              <a:buNone/>
            </a:pP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Oxygen consumption (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,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10 patients), cardiac oxygen efficiency (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,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7 patients) and respiratory quotient (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,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10 patients) while on insulin/glucose and intralipid infusions during intrinsic conduction and optimized cardiac resynchronization therapy (CRT). MVO</a:t>
            </a:r>
            <a:r>
              <a:rPr lang="en-US" sz="16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, minute volume of oxygen; RQ, respiratory quotient. </a:t>
            </a:r>
            <a:r>
              <a:rPr lang="en-GB" sz="1600" b="0" i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600" b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values obtained from paired 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r>
              <a:rPr lang="en-GB" sz="1600" b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ilcoxon signed rank tests.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 algn="just">
              <a:buNone/>
            </a:pP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Picture 5" descr="A graph of different types of oxygen consumption&#10;&#10;Description automatically generated">
            <a:extLst>
              <a:ext uri="{FF2B5EF4-FFF2-40B4-BE49-F238E27FC236}">
                <a16:creationId xmlns:a16="http://schemas.microsoft.com/office/drawing/2014/main" id="{7A38D491-557F-2519-6CF2-6726D299502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1939" y="694199"/>
            <a:ext cx="3543931" cy="3543931"/>
          </a:xfrm>
          <a:prstGeom prst="rect">
            <a:avLst/>
          </a:prstGeom>
        </p:spPr>
      </p:pic>
      <p:pic>
        <p:nvPicPr>
          <p:cNvPr id="9" name="Picture 8" descr="A diagram of a patient's efficiency&#10;&#10;Description automatically generated">
            <a:extLst>
              <a:ext uri="{FF2B5EF4-FFF2-40B4-BE49-F238E27FC236}">
                <a16:creationId xmlns:a16="http://schemas.microsoft.com/office/drawing/2014/main" id="{20A62836-0F54-F04F-15AE-2A1E7BB0EE4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23687" y="694199"/>
            <a:ext cx="3543931" cy="3543931"/>
          </a:xfrm>
          <a:prstGeom prst="rect">
            <a:avLst/>
          </a:prstGeom>
        </p:spPr>
      </p:pic>
      <p:pic>
        <p:nvPicPr>
          <p:cNvPr id="11" name="Picture 10" descr="A graph showing different types of respiratory quotient&#10;&#10;Description automatically generated">
            <a:extLst>
              <a:ext uri="{FF2B5EF4-FFF2-40B4-BE49-F238E27FC236}">
                <a16:creationId xmlns:a16="http://schemas.microsoft.com/office/drawing/2014/main" id="{8E7CF71E-B47D-C8C2-9079-FF294B2C5FF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709671" y="694199"/>
            <a:ext cx="3429000" cy="3429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306343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Content Placeholder 8" descr="A diagram of different uptakes&#10;&#10;Description automatically generated with medium confidence">
            <a:extLst>
              <a:ext uri="{FF2B5EF4-FFF2-40B4-BE49-F238E27FC236}">
                <a16:creationId xmlns:a16="http://schemas.microsoft.com/office/drawing/2014/main" id="{D4F95D49-7BB4-6330-DD71-42B999ADDC4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2919765" y="210184"/>
            <a:ext cx="6352469" cy="5293725"/>
          </a:xfr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BB0415C-EEF3-B248-6035-78F0D69B738B}"/>
              </a:ext>
            </a:extLst>
          </p:cNvPr>
          <p:cNvSpPr txBox="1"/>
          <p:nvPr/>
        </p:nvSpPr>
        <p:spPr>
          <a:xfrm>
            <a:off x="9272234" y="2672301"/>
            <a:ext cx="8018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nfusion</a:t>
            </a:r>
          </a:p>
        </p:txBody>
      </p:sp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71AFAE6E-C9A9-C01B-07FE-E7E4F966F531}"/>
              </a:ext>
            </a:extLst>
          </p:cNvPr>
          <p:cNvSpPr txBox="1">
            <a:spLocks/>
          </p:cNvSpPr>
          <p:nvPr/>
        </p:nvSpPr>
        <p:spPr>
          <a:xfrm>
            <a:off x="575310" y="5561059"/>
            <a:ext cx="110490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buFont typeface="Arial" panose="020B0604020202020204" pitchFamily="34" charset="0"/>
              <a:buNone/>
            </a:pP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4: Cardiac substrate uptake induced by optimized cardiac resynchronization therapy. </a:t>
            </a:r>
          </a:p>
          <a:p>
            <a:pPr marL="0" indent="0" algn="just">
              <a:buFont typeface="Arial" panose="020B0604020202020204" pitchFamily="34" charset="0"/>
              <a:buNone/>
            </a:pP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ardiac uptake of non-esterified free fatty acids (NEFA), </a:t>
            </a:r>
            <a:r>
              <a:rPr lang="el-GR" sz="16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hydroxybutyrate (BOHB), lactate and glucose during intrinsic conduction and optimised cardiac resynchronisation therapy (CRT) while on intralipid and insulin/glucose infusions. Data from 11 patients with </a:t>
            </a:r>
            <a:r>
              <a:rPr lang="en-GB" sz="16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 values obtained from paired Wilcoxon signed rank tests.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7660059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Content Placeholder 6">
            <a:extLst>
              <a:ext uri="{FF2B5EF4-FFF2-40B4-BE49-F238E27FC236}">
                <a16:creationId xmlns:a16="http://schemas.microsoft.com/office/drawing/2014/main" id="{942008B0-395C-6AC5-3100-A23AA2A10E83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910589" y="239078"/>
            <a:ext cx="10443211" cy="4351338"/>
          </a:xfrm>
        </p:spPr>
      </p:pic>
      <p:sp>
        <p:nvSpPr>
          <p:cNvPr id="5" name="Content Placeholder 2">
            <a:extLst>
              <a:ext uri="{FF2B5EF4-FFF2-40B4-BE49-F238E27FC236}">
                <a16:creationId xmlns:a16="http://schemas.microsoft.com/office/drawing/2014/main" id="{2683A464-1E42-03E4-6706-175151AF13D1}"/>
              </a:ext>
            </a:extLst>
          </p:cNvPr>
          <p:cNvSpPr txBox="1">
            <a:spLocks/>
          </p:cNvSpPr>
          <p:nvPr/>
        </p:nvSpPr>
        <p:spPr>
          <a:xfrm>
            <a:off x="910588" y="4831715"/>
            <a:ext cx="10443211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5: Subclassification of fatty acid uptake by chain length</a:t>
            </a:r>
          </a:p>
          <a:p>
            <a:pPr marL="0" indent="0">
              <a:buFont typeface="Arial" panose="020B0604020202020204" pitchFamily="34" charset="0"/>
              <a:buNone/>
            </a:pP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Non-esterified free fatty acid (NEFA) uptakes while on insulin/glucose (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gluc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) and intralipid (intra) infusions during intrinsic conduction and optimized cardiac resynchronization therapy (CRT). Data from 11 patients with unadjusted </a:t>
            </a:r>
            <a:r>
              <a:rPr lang="en-GB" sz="16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 values obtained from paired Wilcoxon signed rank tests.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buFont typeface="Arial" panose="020B0604020202020204" pitchFamily="34" charset="0"/>
              <a:buNone/>
            </a:pP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358107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graph of a graph showing the difference between a number of individuals&#10;&#10;Description automatically generated with medium confidence">
            <a:extLst>
              <a:ext uri="{FF2B5EF4-FFF2-40B4-BE49-F238E27FC236}">
                <a16:creationId xmlns:a16="http://schemas.microsoft.com/office/drawing/2014/main" id="{1185F3C6-58F4-C848-E439-A48AD64412A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09850" y="235676"/>
            <a:ext cx="6972300" cy="4648200"/>
          </a:xfrm>
          <a:prstGeom prst="rect">
            <a:avLst/>
          </a:prstGeom>
        </p:spPr>
      </p:pic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353C2C50-107C-1903-6984-7ECA722EE60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5093736"/>
            <a:ext cx="10515600" cy="4351338"/>
          </a:xfrm>
        </p:spPr>
        <p:txBody>
          <a:bodyPr>
            <a:normAutofit/>
          </a:bodyPr>
          <a:lstStyle/>
          <a:p>
            <a:pPr marL="0" indent="0" algn="just">
              <a:buNone/>
            </a:pP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6: Correlation between cardiac remodeling and QRS duration shortening</a:t>
            </a:r>
          </a:p>
          <a:p>
            <a:pPr marL="0" indent="0" algn="just">
              <a:buNone/>
            </a:pP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Unadjusted correlation between change in left ventricular end diastolic volume (LVEDV) at follow up and acute change in QRS duration induced by optimized cardiac resynchronization therapy. Data from 7 patients with </a:t>
            </a:r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value obtained using Spearman correlation. </a:t>
            </a:r>
            <a:r>
              <a:rPr lang="en-US" sz="16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rey shaded area represents 95% confidence interval limits.</a:t>
            </a:r>
            <a:endParaRPr lang="en-GB" sz="16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indent="0" algn="just">
              <a:buNone/>
            </a:pP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6093470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25A09E95-F13D-B0A6-E3EF-8D7D7110441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21202" y="4847221"/>
            <a:ext cx="11915899" cy="1379959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7: Correlations between acute change in cardiac performance and cardiac remodeling</a:t>
            </a:r>
          </a:p>
          <a:p>
            <a:pPr marL="0" indent="0" algn="just">
              <a:buNone/>
            </a:pP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Unadjusted correlations between acute changes in 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dP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/dt (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,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8 patients), stroke work (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,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5 patients) and cardiac work (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,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5 patients) during insulin/glucose and intralipid infusions and change in left ventricular end diastolic volume (LVEDV) at follow up induced by optimized cardiac resynchronization therapy. </a:t>
            </a:r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values obtained using Spearman correlation. </a:t>
            </a:r>
            <a:r>
              <a:rPr lang="en-US" sz="16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rey shaded area represents 95% confidence interval limits.</a:t>
            </a:r>
            <a:r>
              <a:rPr lang="en-GB" sz="1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dP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/dt, peak change in left ventricular developed pressure/change in time.</a:t>
            </a:r>
          </a:p>
        </p:txBody>
      </p:sp>
      <p:pic>
        <p:nvPicPr>
          <p:cNvPr id="2" name="Picture 1" descr="A graph of stroke work and lvedv reduction&#10;&#10;Description automatically generated">
            <a:extLst>
              <a:ext uri="{FF2B5EF4-FFF2-40B4-BE49-F238E27FC236}">
                <a16:creationId xmlns:a16="http://schemas.microsoft.com/office/drawing/2014/main" id="{B432FA06-E9DB-C835-5439-E8DEA5FC19F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39474" y="759295"/>
            <a:ext cx="3862205" cy="3862205"/>
          </a:xfrm>
          <a:prstGeom prst="rect">
            <a:avLst/>
          </a:prstGeom>
        </p:spPr>
      </p:pic>
      <p:pic>
        <p:nvPicPr>
          <p:cNvPr id="3" name="Picture 2" descr="A graph of a normal blood pressure&#10;&#10;Description automatically generated with medium confidence">
            <a:extLst>
              <a:ext uri="{FF2B5EF4-FFF2-40B4-BE49-F238E27FC236}">
                <a16:creationId xmlns:a16="http://schemas.microsoft.com/office/drawing/2014/main" id="{000A1C04-B36B-4627-5F0A-525C14C6822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301853" y="722381"/>
            <a:ext cx="3862205" cy="3862205"/>
          </a:xfrm>
          <a:prstGeom prst="rect">
            <a:avLst/>
          </a:prstGeom>
        </p:spPr>
      </p:pic>
      <p:pic>
        <p:nvPicPr>
          <p:cNvPr id="4" name="Picture 3" descr="A graph of glucose and lv&#10;&#10;Description automatically generated with medium confidence">
            <a:extLst>
              <a:ext uri="{FF2B5EF4-FFF2-40B4-BE49-F238E27FC236}">
                <a16:creationId xmlns:a16="http://schemas.microsoft.com/office/drawing/2014/main" id="{828F2E02-870C-BEBC-728D-7B4D1F5A552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6013" y="722380"/>
            <a:ext cx="3862205" cy="3862205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9C719C63-9C56-D0D8-8002-4FFEBFE6306D}"/>
              </a:ext>
            </a:extLst>
          </p:cNvPr>
          <p:cNvSpPr txBox="1"/>
          <p:nvPr/>
        </p:nvSpPr>
        <p:spPr>
          <a:xfrm>
            <a:off x="138032" y="728472"/>
            <a:ext cx="33534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D5E1F28-56FA-A2B3-A0B0-4CB40BD21E2E}"/>
              </a:ext>
            </a:extLst>
          </p:cNvPr>
          <p:cNvSpPr txBox="1"/>
          <p:nvPr/>
        </p:nvSpPr>
        <p:spPr>
          <a:xfrm>
            <a:off x="4351026" y="722381"/>
            <a:ext cx="34015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B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898D991-93A0-60B0-E1A6-7698089ACBE2}"/>
              </a:ext>
            </a:extLst>
          </p:cNvPr>
          <p:cNvSpPr txBox="1"/>
          <p:nvPr/>
        </p:nvSpPr>
        <p:spPr>
          <a:xfrm>
            <a:off x="8301853" y="722381"/>
            <a:ext cx="3626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88672362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B4B4CF4-CC23-C54B-5E84-00A6E6BA3FB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24764" y="4953793"/>
            <a:ext cx="11449604" cy="4351338"/>
          </a:xfrm>
        </p:spPr>
        <p:txBody>
          <a:bodyPr>
            <a:normAutofit/>
          </a:bodyPr>
          <a:lstStyle/>
          <a:p>
            <a:pPr marL="0" indent="0" algn="just">
              <a:buNone/>
            </a:pP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1:</a:t>
            </a:r>
          </a:p>
          <a:p>
            <a:pPr marL="0" indent="0" algn="just">
              <a:buNone/>
            </a:pP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orrelation between changes (</a:t>
            </a:r>
            <a:r>
              <a:rPr lang="el-GR" sz="16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in substrate uptake following improvements in cardiac performance induced by initiation of optimized cardiac resynchronization therapy, while on insulin/glucose and intralipid infusions. Data from 10 patients with </a:t>
            </a:r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values obtained from spearman correlation with no correction for false discovery rate. BOHB,</a:t>
            </a:r>
            <a:r>
              <a:rPr lang="el-GR" sz="16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β</a:t>
            </a:r>
            <a:r>
              <a:rPr lang="el-GR" sz="1600" b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GB" sz="1600" b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hydroxybutyrate;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dP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dt</a:t>
            </a:r>
            <a:r>
              <a:rPr lang="en-US" sz="16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max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, peak change in pressure/change in time; NEFA, non-esterified free fatty acids.</a:t>
            </a:r>
          </a:p>
          <a:p>
            <a:pPr marL="0" indent="0" algn="just">
              <a:buNone/>
            </a:pP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EB34C8B-4A7D-9FFD-1E91-91C9A974262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150" t="8087" r="3552" b="77049"/>
          <a:stretch/>
        </p:blipFill>
        <p:spPr>
          <a:xfrm>
            <a:off x="371198" y="1709335"/>
            <a:ext cx="11449604" cy="26378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5374676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8719DDEA-0532-F685-7FC8-46B873321D0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896" t="31932" r="3661" b="56129"/>
          <a:stretch/>
        </p:blipFill>
        <p:spPr>
          <a:xfrm>
            <a:off x="413274" y="2367451"/>
            <a:ext cx="11365453" cy="2123099"/>
          </a:xfrm>
          <a:prstGeom prst="rect">
            <a:avLst/>
          </a:prstGeom>
        </p:spPr>
      </p:pic>
      <p:sp>
        <p:nvSpPr>
          <p:cNvPr id="5" name="Content Placeholder 2">
            <a:extLst>
              <a:ext uri="{FF2B5EF4-FFF2-40B4-BE49-F238E27FC236}">
                <a16:creationId xmlns:a16="http://schemas.microsoft.com/office/drawing/2014/main" id="{DC2EBFAC-BFBE-59DA-3CC6-29A9BC44A47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24764" y="4953793"/>
            <a:ext cx="11449604" cy="4351338"/>
          </a:xfrm>
        </p:spPr>
        <p:txBody>
          <a:bodyPr>
            <a:normAutofit/>
          </a:bodyPr>
          <a:lstStyle/>
          <a:p>
            <a:pPr marL="0" indent="0" algn="just">
              <a:buNone/>
            </a:pP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2:</a:t>
            </a:r>
          </a:p>
          <a:p>
            <a:pPr marL="0" indent="0" algn="just">
              <a:buNone/>
            </a:pP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orrelation between changes (</a:t>
            </a:r>
            <a:r>
              <a:rPr lang="el-GR" sz="16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in substrate uptake while on insulin/glucose and intralipid infusions and subsequent </a:t>
            </a: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</a:rPr>
              <a:t>chronic reverse remodeling of left ventricular end diastolic volume </a:t>
            </a:r>
            <a:r>
              <a:rPr lang="en-US" sz="16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(LVEDV) and left ventricular ejection fraction (LVEF) induced by optimized cardiac resynchronization therap</a:t>
            </a:r>
            <a:r>
              <a:rPr lang="en-US" sz="16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y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. Data from 10 patients with </a:t>
            </a:r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values obtained from spearman correlation with no correction for false discovery rate. BOHB,</a:t>
            </a:r>
            <a:r>
              <a:rPr lang="el-GR" sz="16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β</a:t>
            </a:r>
            <a:r>
              <a:rPr lang="el-GR" sz="1600" b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GB" sz="1600" b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hydroxybutyrate;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NEFA, non-esterified free fatty acids.</a:t>
            </a:r>
          </a:p>
          <a:p>
            <a:pPr marL="0" indent="0" algn="just">
              <a:buNone/>
            </a:pP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144018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954</TotalTime>
  <Words>782</Words>
  <Application>Microsoft Macintosh PowerPoint</Application>
  <PresentationFormat>Widescreen</PresentationFormat>
  <Paragraphs>31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5" baseType="lpstr">
      <vt:lpstr>Aptos</vt:lpstr>
      <vt:lpstr>Aptos Display</vt:lpstr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</dc:title>
  <dc:creator>Benjamin Bussmann</dc:creator>
  <cp:lastModifiedBy>Neil Herring</cp:lastModifiedBy>
  <cp:revision>35</cp:revision>
  <dcterms:created xsi:type="dcterms:W3CDTF">2024-07-19T13:13:27Z</dcterms:created>
  <dcterms:modified xsi:type="dcterms:W3CDTF">2025-02-03T14:31:28Z</dcterms:modified>
</cp:coreProperties>
</file>